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906000" type="A4"/>
  <p:notesSz cx="6797675" cy="9928225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4" userDrawn="1">
          <p15:clr>
            <a:srgbClr val="A4A3A4"/>
          </p15:clr>
        </p15:guide>
        <p15:guide id="2" pos="4163" userDrawn="1">
          <p15:clr>
            <a:srgbClr val="A4A3A4"/>
          </p15:clr>
        </p15:guide>
        <p15:guide id="3" pos="269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arah Sugiarto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20" d="100"/>
          <a:sy n="120" d="100"/>
        </p:scale>
        <p:origin x="1314" y="84"/>
      </p:cViewPr>
      <p:guideLst>
        <p:guide orient="horz" pos="434"/>
        <p:guide pos="4163"/>
        <p:guide pos="269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rbarawilli:Library:Mail%20Downloads:Resultate%20Mastertabelle-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rbarawilli:Library:Mail%20Downloads:Resultate%20Mastertabelle-1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arbarawilli:Library:Mail%20Downloads:Resultate%20Mastertabelle-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351145038168"/>
          <c:y val="0.28962084021385698"/>
          <c:w val="0.59906882250405702"/>
          <c:h val="0.53050158905376299"/>
        </c:manualLayout>
      </c:layout>
      <c:scatterChart>
        <c:scatterStyle val="lineMarker"/>
        <c:varyColors val="0"/>
        <c:ser>
          <c:idx val="0"/>
          <c:order val="0"/>
          <c:tx>
            <c:strRef>
              <c:f>Bili!$B$48</c:f>
              <c:strCache>
                <c:ptCount val="1"/>
                <c:pt idx="0">
                  <c:v>Group A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ili!$D$53:$S$53</c:f>
                <c:numCache>
                  <c:formatCode>General</c:formatCode>
                  <c:ptCount val="16"/>
                  <c:pt idx="0">
                    <c:v>9.2561035543951897E-2</c:v>
                  </c:pt>
                  <c:pt idx="1">
                    <c:v>0.15532708413750501</c:v>
                  </c:pt>
                  <c:pt idx="2">
                    <c:v>0.120295773996502</c:v>
                  </c:pt>
                  <c:pt idx="3">
                    <c:v>0.13013558543916801</c:v>
                  </c:pt>
                  <c:pt idx="4">
                    <c:v>0.26770135915184201</c:v>
                  </c:pt>
                  <c:pt idx="5">
                    <c:v>0.248553365464182</c:v>
                  </c:pt>
                  <c:pt idx="6">
                    <c:v>0.51617484656583301</c:v>
                  </c:pt>
                  <c:pt idx="7">
                    <c:v>0.61040301962982402</c:v>
                  </c:pt>
                  <c:pt idx="8">
                    <c:v>2.3808914552683378</c:v>
                  </c:pt>
                  <c:pt idx="9">
                    <c:v>2.130624833795129</c:v>
                  </c:pt>
                  <c:pt idx="10">
                    <c:v>0.957747436227396</c:v>
                  </c:pt>
                  <c:pt idx="11">
                    <c:v>0.84888863212322396</c:v>
                  </c:pt>
                  <c:pt idx="12">
                    <c:v>0.71818296932612502</c:v>
                  </c:pt>
                  <c:pt idx="13">
                    <c:v>0.61562725427294895</c:v>
                  </c:pt>
                  <c:pt idx="14">
                    <c:v>0.38963602795076901</c:v>
                  </c:pt>
                  <c:pt idx="15">
                    <c:v>0.26465799229426201</c:v>
                  </c:pt>
                </c:numCache>
              </c:numRef>
            </c:plus>
            <c:minus>
              <c:numRef>
                <c:f>Bili!$D$53:$S$53</c:f>
                <c:numCache>
                  <c:formatCode>General</c:formatCode>
                  <c:ptCount val="16"/>
                  <c:pt idx="0">
                    <c:v>9.2561035543951897E-2</c:v>
                  </c:pt>
                  <c:pt idx="1">
                    <c:v>0.15532708413750501</c:v>
                  </c:pt>
                  <c:pt idx="2">
                    <c:v>0.120295773996502</c:v>
                  </c:pt>
                  <c:pt idx="3">
                    <c:v>0.13013558543916801</c:v>
                  </c:pt>
                  <c:pt idx="4">
                    <c:v>0.26770135915184201</c:v>
                  </c:pt>
                  <c:pt idx="5">
                    <c:v>0.248553365464182</c:v>
                  </c:pt>
                  <c:pt idx="6">
                    <c:v>0.51617484656583301</c:v>
                  </c:pt>
                  <c:pt idx="7">
                    <c:v>0.61040301962982402</c:v>
                  </c:pt>
                  <c:pt idx="8">
                    <c:v>2.3808914552683378</c:v>
                  </c:pt>
                  <c:pt idx="9">
                    <c:v>2.130624833795129</c:v>
                  </c:pt>
                  <c:pt idx="10">
                    <c:v>0.957747436227396</c:v>
                  </c:pt>
                  <c:pt idx="11">
                    <c:v>0.84888863212322396</c:v>
                  </c:pt>
                  <c:pt idx="12">
                    <c:v>0.71818296932612502</c:v>
                  </c:pt>
                  <c:pt idx="13">
                    <c:v>0.61562725427294895</c:v>
                  </c:pt>
                  <c:pt idx="14">
                    <c:v>0.38963602795076901</c:v>
                  </c:pt>
                  <c:pt idx="15">
                    <c:v>0.26465799229426201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noFill/>
                <a:round/>
              </a:ln>
              <a:effectLst/>
            </c:spPr>
          </c:errBars>
          <c:xVal>
            <c:numRef>
              <c:f>Bili!$D$47:$S$47</c:f>
              <c:numCache>
                <c:formatCode>General</c:formatCode>
                <c:ptCount val="16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  <c:pt idx="7">
                  <c:v>42</c:v>
                </c:pt>
                <c:pt idx="8">
                  <c:v>49</c:v>
                </c:pt>
                <c:pt idx="9">
                  <c:v>56</c:v>
                </c:pt>
                <c:pt idx="10">
                  <c:v>63</c:v>
                </c:pt>
                <c:pt idx="11">
                  <c:v>70</c:v>
                </c:pt>
                <c:pt idx="12">
                  <c:v>76</c:v>
                </c:pt>
                <c:pt idx="13">
                  <c:v>84</c:v>
                </c:pt>
                <c:pt idx="14">
                  <c:v>91</c:v>
                </c:pt>
                <c:pt idx="15">
                  <c:v>98</c:v>
                </c:pt>
              </c:numCache>
            </c:numRef>
          </c:xVal>
          <c:yVal>
            <c:numRef>
              <c:f>Bili!$D$48:$S$48</c:f>
              <c:numCache>
                <c:formatCode>General</c:formatCode>
                <c:ptCount val="16"/>
                <c:pt idx="0">
                  <c:v>0.16850686300000001</c:v>
                </c:pt>
                <c:pt idx="1">
                  <c:v>0.205274777777778</c:v>
                </c:pt>
                <c:pt idx="2">
                  <c:v>0.212021501</c:v>
                </c:pt>
                <c:pt idx="3">
                  <c:v>0.144140403</c:v>
                </c:pt>
                <c:pt idx="4">
                  <c:v>0.34764812</c:v>
                </c:pt>
                <c:pt idx="5">
                  <c:v>0.73917272000000001</c:v>
                </c:pt>
                <c:pt idx="6">
                  <c:v>0.80858658000000005</c:v>
                </c:pt>
                <c:pt idx="7">
                  <c:v>0.84065022</c:v>
                </c:pt>
                <c:pt idx="8">
                  <c:v>2.2578300699999998</c:v>
                </c:pt>
                <c:pt idx="9">
                  <c:v>1.97219955</c:v>
                </c:pt>
                <c:pt idx="10">
                  <c:v>1.37843081</c:v>
                </c:pt>
                <c:pt idx="11">
                  <c:v>1.15565842</c:v>
                </c:pt>
                <c:pt idx="12">
                  <c:v>0.93475132100000002</c:v>
                </c:pt>
                <c:pt idx="13">
                  <c:v>0.61535345299999999</c:v>
                </c:pt>
                <c:pt idx="14">
                  <c:v>0.80953096000000002</c:v>
                </c:pt>
                <c:pt idx="15">
                  <c:v>0.416621738000000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Bili!$B$49</c:f>
              <c:strCache>
                <c:ptCount val="1"/>
                <c:pt idx="0">
                  <c:v>Group B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5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ili!$D$54:$S$54</c:f>
                <c:numCache>
                  <c:formatCode>General</c:formatCode>
                  <c:ptCount val="16"/>
                  <c:pt idx="0">
                    <c:v>0.163784041160255</c:v>
                  </c:pt>
                  <c:pt idx="1">
                    <c:v>0.18311014041995199</c:v>
                  </c:pt>
                  <c:pt idx="2">
                    <c:v>0.290653187953958</c:v>
                  </c:pt>
                  <c:pt idx="3">
                    <c:v>0.308566428591806</c:v>
                  </c:pt>
                  <c:pt idx="4">
                    <c:v>5.2452127744220298E-2</c:v>
                  </c:pt>
                  <c:pt idx="5">
                    <c:v>0.215104766668966</c:v>
                  </c:pt>
                  <c:pt idx="6">
                    <c:v>0.22184460162561001</c:v>
                  </c:pt>
                  <c:pt idx="7">
                    <c:v>0.29047684996398299</c:v>
                  </c:pt>
                  <c:pt idx="8">
                    <c:v>0.58579393676445501</c:v>
                  </c:pt>
                  <c:pt idx="9">
                    <c:v>0.92337837625105901</c:v>
                  </c:pt>
                  <c:pt idx="10">
                    <c:v>0.32802937357624801</c:v>
                  </c:pt>
                  <c:pt idx="11">
                    <c:v>0.473239899978186</c:v>
                  </c:pt>
                  <c:pt idx="12">
                    <c:v>0.33169734763735698</c:v>
                  </c:pt>
                  <c:pt idx="13">
                    <c:v>0.173965283493552</c:v>
                  </c:pt>
                  <c:pt idx="14">
                    <c:v>0.207691037042671</c:v>
                  </c:pt>
                  <c:pt idx="15">
                    <c:v>0.18552456410215201</c:v>
                  </c:pt>
                </c:numCache>
              </c:numRef>
            </c:plus>
            <c:minus>
              <c:numRef>
                <c:f>Bili!$D$54:$S$54</c:f>
                <c:numCache>
                  <c:formatCode>General</c:formatCode>
                  <c:ptCount val="16"/>
                  <c:pt idx="0">
                    <c:v>0.163784041160255</c:v>
                  </c:pt>
                  <c:pt idx="1">
                    <c:v>0.18311014041995199</c:v>
                  </c:pt>
                  <c:pt idx="2">
                    <c:v>0.290653187953958</c:v>
                  </c:pt>
                  <c:pt idx="3">
                    <c:v>0.308566428591806</c:v>
                  </c:pt>
                  <c:pt idx="4">
                    <c:v>5.2452127744220298E-2</c:v>
                  </c:pt>
                  <c:pt idx="5">
                    <c:v>0.215104766668966</c:v>
                  </c:pt>
                  <c:pt idx="6">
                    <c:v>0.22184460162561001</c:v>
                  </c:pt>
                  <c:pt idx="7">
                    <c:v>0.29047684996398299</c:v>
                  </c:pt>
                  <c:pt idx="8">
                    <c:v>0.58579393676445501</c:v>
                  </c:pt>
                  <c:pt idx="9">
                    <c:v>0.92337837625105901</c:v>
                  </c:pt>
                  <c:pt idx="10">
                    <c:v>0.32802937357624801</c:v>
                  </c:pt>
                  <c:pt idx="11">
                    <c:v>0.473239899978186</c:v>
                  </c:pt>
                  <c:pt idx="12">
                    <c:v>0.33169734763735698</c:v>
                  </c:pt>
                  <c:pt idx="13">
                    <c:v>0.173965283493552</c:v>
                  </c:pt>
                  <c:pt idx="14">
                    <c:v>0.207691037042671</c:v>
                  </c:pt>
                  <c:pt idx="15">
                    <c:v>0.18552456410215201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noFill/>
                <a:round/>
              </a:ln>
              <a:effectLst/>
            </c:spPr>
          </c:errBars>
          <c:xVal>
            <c:numRef>
              <c:f>Bili!$D$47:$S$47</c:f>
              <c:numCache>
                <c:formatCode>General</c:formatCode>
                <c:ptCount val="16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  <c:pt idx="7">
                  <c:v>42</c:v>
                </c:pt>
                <c:pt idx="8">
                  <c:v>49</c:v>
                </c:pt>
                <c:pt idx="9">
                  <c:v>56</c:v>
                </c:pt>
                <c:pt idx="10">
                  <c:v>63</c:v>
                </c:pt>
                <c:pt idx="11">
                  <c:v>70</c:v>
                </c:pt>
                <c:pt idx="12">
                  <c:v>76</c:v>
                </c:pt>
                <c:pt idx="13">
                  <c:v>84</c:v>
                </c:pt>
                <c:pt idx="14">
                  <c:v>91</c:v>
                </c:pt>
                <c:pt idx="15">
                  <c:v>98</c:v>
                </c:pt>
              </c:numCache>
            </c:numRef>
          </c:xVal>
          <c:yVal>
            <c:numRef>
              <c:f>Bili!$D$49:$S$49</c:f>
              <c:numCache>
                <c:formatCode>General</c:formatCode>
                <c:ptCount val="16"/>
                <c:pt idx="0">
                  <c:v>0.37191030000000003</c:v>
                </c:pt>
                <c:pt idx="1">
                  <c:v>0.27770756000000002</c:v>
                </c:pt>
                <c:pt idx="2">
                  <c:v>0.321735826</c:v>
                </c:pt>
                <c:pt idx="3">
                  <c:v>0.41587545999999997</c:v>
                </c:pt>
                <c:pt idx="4">
                  <c:v>0.14010510000000001</c:v>
                </c:pt>
                <c:pt idx="5">
                  <c:v>0.41273707250000002</c:v>
                </c:pt>
                <c:pt idx="6">
                  <c:v>0.51873851999999998</c:v>
                </c:pt>
                <c:pt idx="7">
                  <c:v>0.59659264000000001</c:v>
                </c:pt>
                <c:pt idx="8">
                  <c:v>1.20255896</c:v>
                </c:pt>
                <c:pt idx="9">
                  <c:v>1.1781681799999999</c:v>
                </c:pt>
                <c:pt idx="10">
                  <c:v>0.56594767999999995</c:v>
                </c:pt>
                <c:pt idx="11">
                  <c:v>0.81421399999999999</c:v>
                </c:pt>
                <c:pt idx="12">
                  <c:v>0.85595387999999994</c:v>
                </c:pt>
                <c:pt idx="13">
                  <c:v>0.43899559999999999</c:v>
                </c:pt>
                <c:pt idx="14">
                  <c:v>0.31357295000000002</c:v>
                </c:pt>
                <c:pt idx="15">
                  <c:v>0.42366157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478808"/>
        <c:axId val="178479984"/>
      </c:scatterChart>
      <c:valAx>
        <c:axId val="178478808"/>
        <c:scaling>
          <c:orientation val="minMax"/>
          <c:max val="10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GB"/>
                  <a:t>Days post inoculat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fr-FR"/>
          </a:p>
        </c:txPr>
        <c:crossAx val="178479984"/>
        <c:crosses val="autoZero"/>
        <c:crossBetween val="midCat"/>
        <c:majorUnit val="10"/>
      </c:valAx>
      <c:valAx>
        <c:axId val="17847998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/>
                  <a:t>Bilirubin (µ</a:t>
                </a:r>
                <a:r>
                  <a:rPr lang="en-GB" dirty="0" err="1"/>
                  <a:t>mol</a:t>
                </a:r>
                <a:r>
                  <a:rPr lang="en-GB" dirty="0" smtClean="0"/>
                  <a:t>/L)</a:t>
                </a:r>
                <a:endParaRPr lang="en-GB" dirty="0"/>
              </a:p>
            </c:rich>
          </c:tx>
          <c:layout>
            <c:manualLayout>
              <c:xMode val="edge"/>
              <c:yMode val="edge"/>
              <c:x val="3.5587906473522897E-2"/>
              <c:y val="0.2985817235969330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fr-FR"/>
          </a:p>
        </c:txPr>
        <c:crossAx val="17847880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4347851175091695"/>
          <c:y val="3.9827143923381297E-2"/>
          <c:w val="0.25304278215223103"/>
          <c:h val="0.30923783659312598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fr-F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rgbClr val="000000"/>
          </a:solidFill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09247740983499"/>
          <c:y val="8.3203857514275906E-2"/>
          <c:w val="0.76201639010790601"/>
          <c:h val="0.64576524618716202"/>
        </c:manualLayout>
      </c:layout>
      <c:scatterChart>
        <c:scatterStyle val="lineMarker"/>
        <c:varyColors val="0"/>
        <c:ser>
          <c:idx val="0"/>
          <c:order val="0"/>
          <c:tx>
            <c:strRef>
              <c:f>Globuline!$B$85</c:f>
              <c:strCache>
                <c:ptCount val="1"/>
                <c:pt idx="0">
                  <c:v>Group A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obuline!$D$90:$S$90</c:f>
                <c:numCache>
                  <c:formatCode>General</c:formatCode>
                  <c:ptCount val="16"/>
                  <c:pt idx="0">
                    <c:v>2.7979621193306108</c:v>
                  </c:pt>
                  <c:pt idx="1">
                    <c:v>5.7448005533167716</c:v>
                  </c:pt>
                  <c:pt idx="2">
                    <c:v>2.2095487211698761</c:v>
                  </c:pt>
                  <c:pt idx="3">
                    <c:v>2.2579255278640171</c:v>
                  </c:pt>
                  <c:pt idx="4">
                    <c:v>2.9647650186286172</c:v>
                  </c:pt>
                  <c:pt idx="5">
                    <c:v>3.9774303625808369</c:v>
                  </c:pt>
                  <c:pt idx="6">
                    <c:v>4.27368812570593</c:v>
                  </c:pt>
                  <c:pt idx="7">
                    <c:v>3.5128397884412679</c:v>
                  </c:pt>
                  <c:pt idx="8">
                    <c:v>5.8512035221602741</c:v>
                  </c:pt>
                  <c:pt idx="9">
                    <c:v>5.1743046185322346</c:v>
                  </c:pt>
                  <c:pt idx="10">
                    <c:v>4.7866017828735901</c:v>
                  </c:pt>
                  <c:pt idx="11">
                    <c:v>4.9997374540490567</c:v>
                  </c:pt>
                  <c:pt idx="12">
                    <c:v>3.496348073899326</c:v>
                  </c:pt>
                  <c:pt idx="13">
                    <c:v>2.0331798815522939</c:v>
                  </c:pt>
                  <c:pt idx="14">
                    <c:v>2.58469030876351</c:v>
                  </c:pt>
                  <c:pt idx="15">
                    <c:v>2.6022633820357242</c:v>
                  </c:pt>
                </c:numCache>
              </c:numRef>
            </c:plus>
            <c:minus>
              <c:numRef>
                <c:f>Globuline!$D$90:$S$90</c:f>
                <c:numCache>
                  <c:formatCode>General</c:formatCode>
                  <c:ptCount val="16"/>
                  <c:pt idx="0">
                    <c:v>2.7979621193306108</c:v>
                  </c:pt>
                  <c:pt idx="1">
                    <c:v>5.7448005533167716</c:v>
                  </c:pt>
                  <c:pt idx="2">
                    <c:v>2.2095487211698761</c:v>
                  </c:pt>
                  <c:pt idx="3">
                    <c:v>2.2579255278640171</c:v>
                  </c:pt>
                  <c:pt idx="4">
                    <c:v>2.9647650186286172</c:v>
                  </c:pt>
                  <c:pt idx="5">
                    <c:v>3.9774303625808369</c:v>
                  </c:pt>
                  <c:pt idx="6">
                    <c:v>4.27368812570593</c:v>
                  </c:pt>
                  <c:pt idx="7">
                    <c:v>3.5128397884412679</c:v>
                  </c:pt>
                  <c:pt idx="8">
                    <c:v>5.8512035221602741</c:v>
                  </c:pt>
                  <c:pt idx="9">
                    <c:v>5.1743046185322346</c:v>
                  </c:pt>
                  <c:pt idx="10">
                    <c:v>4.7866017828735901</c:v>
                  </c:pt>
                  <c:pt idx="11">
                    <c:v>4.9997374540490567</c:v>
                  </c:pt>
                  <c:pt idx="12">
                    <c:v>3.496348073899326</c:v>
                  </c:pt>
                  <c:pt idx="13">
                    <c:v>2.0331798815522939</c:v>
                  </c:pt>
                  <c:pt idx="14">
                    <c:v>2.58469030876351</c:v>
                  </c:pt>
                  <c:pt idx="15">
                    <c:v>2.6022633820357242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noFill/>
                <a:round/>
              </a:ln>
              <a:effectLst/>
            </c:spPr>
          </c:errBars>
          <c:xVal>
            <c:numRef>
              <c:f>Globuline!$D$84:$S$84</c:f>
              <c:numCache>
                <c:formatCode>General</c:formatCode>
                <c:ptCount val="16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  <c:pt idx="7">
                  <c:v>42</c:v>
                </c:pt>
                <c:pt idx="8">
                  <c:v>49</c:v>
                </c:pt>
                <c:pt idx="9">
                  <c:v>56</c:v>
                </c:pt>
                <c:pt idx="10">
                  <c:v>63</c:v>
                </c:pt>
                <c:pt idx="11">
                  <c:v>70</c:v>
                </c:pt>
                <c:pt idx="12">
                  <c:v>76</c:v>
                </c:pt>
                <c:pt idx="13">
                  <c:v>84</c:v>
                </c:pt>
                <c:pt idx="14">
                  <c:v>91</c:v>
                </c:pt>
                <c:pt idx="15">
                  <c:v>98</c:v>
                </c:pt>
              </c:numCache>
            </c:numRef>
          </c:xVal>
          <c:yVal>
            <c:numRef>
              <c:f>Globuline!$D$85:$S$85</c:f>
              <c:numCache>
                <c:formatCode>General</c:formatCode>
                <c:ptCount val="16"/>
                <c:pt idx="0">
                  <c:v>23.438001</c:v>
                </c:pt>
                <c:pt idx="1">
                  <c:v>29.198681000000001</c:v>
                </c:pt>
                <c:pt idx="2">
                  <c:v>25.39116375</c:v>
                </c:pt>
                <c:pt idx="3">
                  <c:v>24.35398</c:v>
                </c:pt>
                <c:pt idx="4">
                  <c:v>29.472543999999932</c:v>
                </c:pt>
                <c:pt idx="5">
                  <c:v>27.506730000000001</c:v>
                </c:pt>
                <c:pt idx="6">
                  <c:v>30.732980000000001</c:v>
                </c:pt>
                <c:pt idx="7">
                  <c:v>32.638972000000003</c:v>
                </c:pt>
                <c:pt idx="8">
                  <c:v>31.190916999999999</c:v>
                </c:pt>
                <c:pt idx="9">
                  <c:v>30.747575999999999</c:v>
                </c:pt>
                <c:pt idx="10">
                  <c:v>32.317979000000001</c:v>
                </c:pt>
                <c:pt idx="11">
                  <c:v>31.194966999999998</c:v>
                </c:pt>
                <c:pt idx="12">
                  <c:v>30.980650000000001</c:v>
                </c:pt>
                <c:pt idx="13">
                  <c:v>29.207889000000009</c:v>
                </c:pt>
                <c:pt idx="14">
                  <c:v>28.908031999999999</c:v>
                </c:pt>
                <c:pt idx="15">
                  <c:v>27.96317600000000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Globuline!$B$86</c:f>
              <c:strCache>
                <c:ptCount val="1"/>
                <c:pt idx="0">
                  <c:v>Group B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5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obuline!$D$91:$S$91</c:f>
                <c:numCache>
                  <c:formatCode>General</c:formatCode>
                  <c:ptCount val="16"/>
                  <c:pt idx="0">
                    <c:v>2.2567338124466518</c:v>
                  </c:pt>
                  <c:pt idx="1">
                    <c:v>2.8351611284129632</c:v>
                  </c:pt>
                  <c:pt idx="2">
                    <c:v>2.7909921185227118</c:v>
                  </c:pt>
                  <c:pt idx="3">
                    <c:v>2.7318966433406939</c:v>
                  </c:pt>
                  <c:pt idx="4">
                    <c:v>3.3713795612680411</c:v>
                  </c:pt>
                  <c:pt idx="5">
                    <c:v>2.9893150368395411</c:v>
                  </c:pt>
                  <c:pt idx="6">
                    <c:v>2.6856624218959442</c:v>
                  </c:pt>
                  <c:pt idx="7">
                    <c:v>8.9742729100503489</c:v>
                  </c:pt>
                  <c:pt idx="8">
                    <c:v>5.6843026390951277</c:v>
                  </c:pt>
                  <c:pt idx="9">
                    <c:v>7.2151690006829448</c:v>
                  </c:pt>
                  <c:pt idx="10">
                    <c:v>7.8587111560015934</c:v>
                  </c:pt>
                  <c:pt idx="11">
                    <c:v>5.9262830863555678</c:v>
                  </c:pt>
                  <c:pt idx="12">
                    <c:v>4.7371975018586561</c:v>
                  </c:pt>
                  <c:pt idx="13">
                    <c:v>4.2833342146202327</c:v>
                  </c:pt>
                  <c:pt idx="14">
                    <c:v>3.4871747302766698</c:v>
                  </c:pt>
                  <c:pt idx="15">
                    <c:v>2.7848274344281929</c:v>
                  </c:pt>
                </c:numCache>
              </c:numRef>
            </c:plus>
            <c:minus>
              <c:numRef>
                <c:f>Globuline!$D$91:$S$91</c:f>
                <c:numCache>
                  <c:formatCode>General</c:formatCode>
                  <c:ptCount val="16"/>
                  <c:pt idx="0">
                    <c:v>2.2567338124466518</c:v>
                  </c:pt>
                  <c:pt idx="1">
                    <c:v>2.8351611284129632</c:v>
                  </c:pt>
                  <c:pt idx="2">
                    <c:v>2.7909921185227118</c:v>
                  </c:pt>
                  <c:pt idx="3">
                    <c:v>2.7318966433406939</c:v>
                  </c:pt>
                  <c:pt idx="4">
                    <c:v>3.3713795612680411</c:v>
                  </c:pt>
                  <c:pt idx="5">
                    <c:v>2.9893150368395411</c:v>
                  </c:pt>
                  <c:pt idx="6">
                    <c:v>2.6856624218959442</c:v>
                  </c:pt>
                  <c:pt idx="7">
                    <c:v>8.9742729100503489</c:v>
                  </c:pt>
                  <c:pt idx="8">
                    <c:v>5.6843026390951277</c:v>
                  </c:pt>
                  <c:pt idx="9">
                    <c:v>7.2151690006829448</c:v>
                  </c:pt>
                  <c:pt idx="10">
                    <c:v>7.8587111560015934</c:v>
                  </c:pt>
                  <c:pt idx="11">
                    <c:v>5.9262830863555678</c:v>
                  </c:pt>
                  <c:pt idx="12">
                    <c:v>4.7371975018586561</c:v>
                  </c:pt>
                  <c:pt idx="13">
                    <c:v>4.2833342146202327</c:v>
                  </c:pt>
                  <c:pt idx="14">
                    <c:v>3.4871747302766698</c:v>
                  </c:pt>
                  <c:pt idx="15">
                    <c:v>2.7848274344281929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noFill/>
                <a:round/>
              </a:ln>
              <a:effectLst/>
            </c:spPr>
          </c:errBars>
          <c:xVal>
            <c:numRef>
              <c:f>Globuline!$D$84:$S$84</c:f>
              <c:numCache>
                <c:formatCode>General</c:formatCode>
                <c:ptCount val="16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  <c:pt idx="7">
                  <c:v>42</c:v>
                </c:pt>
                <c:pt idx="8">
                  <c:v>49</c:v>
                </c:pt>
                <c:pt idx="9">
                  <c:v>56</c:v>
                </c:pt>
                <c:pt idx="10">
                  <c:v>63</c:v>
                </c:pt>
                <c:pt idx="11">
                  <c:v>70</c:v>
                </c:pt>
                <c:pt idx="12">
                  <c:v>76</c:v>
                </c:pt>
                <c:pt idx="13">
                  <c:v>84</c:v>
                </c:pt>
                <c:pt idx="14">
                  <c:v>91</c:v>
                </c:pt>
                <c:pt idx="15">
                  <c:v>98</c:v>
                </c:pt>
              </c:numCache>
            </c:numRef>
          </c:xVal>
          <c:yVal>
            <c:numRef>
              <c:f>Globuline!$D$86:$S$86</c:f>
              <c:numCache>
                <c:formatCode>General</c:formatCode>
                <c:ptCount val="16"/>
                <c:pt idx="0">
                  <c:v>23.365459999999999</c:v>
                </c:pt>
                <c:pt idx="1">
                  <c:v>26.504874000000001</c:v>
                </c:pt>
                <c:pt idx="2">
                  <c:v>24.025331999999999</c:v>
                </c:pt>
                <c:pt idx="3">
                  <c:v>23.268348</c:v>
                </c:pt>
                <c:pt idx="4">
                  <c:v>24.191158000000001</c:v>
                </c:pt>
                <c:pt idx="5">
                  <c:v>24.072265000000009</c:v>
                </c:pt>
                <c:pt idx="6">
                  <c:v>25.142474</c:v>
                </c:pt>
                <c:pt idx="7">
                  <c:v>28.708756000000001</c:v>
                </c:pt>
                <c:pt idx="8">
                  <c:v>25.725176000000001</c:v>
                </c:pt>
                <c:pt idx="9">
                  <c:v>27.553922</c:v>
                </c:pt>
                <c:pt idx="10">
                  <c:v>28.828084</c:v>
                </c:pt>
                <c:pt idx="11">
                  <c:v>27.902676</c:v>
                </c:pt>
                <c:pt idx="12">
                  <c:v>28.612442000000001</c:v>
                </c:pt>
                <c:pt idx="13">
                  <c:v>26.470302</c:v>
                </c:pt>
                <c:pt idx="14">
                  <c:v>26.44847</c:v>
                </c:pt>
                <c:pt idx="15">
                  <c:v>26.579764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481944"/>
        <c:axId val="178481552"/>
      </c:scatterChart>
      <c:valAx>
        <c:axId val="178481944"/>
        <c:scaling>
          <c:orientation val="minMax"/>
          <c:max val="10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GB" dirty="0"/>
                  <a:t>Days </a:t>
                </a:r>
                <a:r>
                  <a:rPr lang="en-GB" dirty="0" smtClean="0"/>
                  <a:t>post inoculation</a:t>
                </a:r>
                <a:endParaRPr lang="en-GB" dirty="0"/>
              </a:p>
            </c:rich>
          </c:tx>
          <c:layout>
            <c:manualLayout>
              <c:xMode val="edge"/>
              <c:yMode val="edge"/>
              <c:x val="0.36779313835717298"/>
              <c:y val="0.8527931751670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fr-FR"/>
          </a:p>
        </c:txPr>
        <c:crossAx val="178481552"/>
        <c:crosses val="autoZero"/>
        <c:crossBetween val="midCat"/>
        <c:majorUnit val="10"/>
      </c:valAx>
      <c:valAx>
        <c:axId val="178481552"/>
        <c:scaling>
          <c:orientation val="minMax"/>
          <c:min val="1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 smtClean="0"/>
                  <a:t>Globulin </a:t>
                </a:r>
                <a:r>
                  <a:rPr lang="en-GB" dirty="0"/>
                  <a:t>(g</a:t>
                </a:r>
                <a:r>
                  <a:rPr lang="en-GB" dirty="0" smtClean="0"/>
                  <a:t>/L)</a:t>
                </a:r>
                <a:endParaRPr lang="en-GB" dirty="0"/>
              </a:p>
            </c:rich>
          </c:tx>
          <c:layout>
            <c:manualLayout>
              <c:xMode val="edge"/>
              <c:yMode val="edge"/>
              <c:x val="2.4031676398654601E-2"/>
              <c:y val="0.22256704310826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fr-FR"/>
          </a:p>
        </c:txPr>
        <c:crossAx val="1784819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rnd" cmpd="sng" algn="ctr">
      <a:noFill/>
      <a:round/>
    </a:ln>
    <a:effectLst/>
  </c:spPr>
  <c:txPr>
    <a:bodyPr/>
    <a:lstStyle/>
    <a:p>
      <a:pPr>
        <a:defRPr>
          <a:solidFill>
            <a:srgbClr val="000000"/>
          </a:solidFill>
        </a:defRPr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984282606697"/>
          <c:y val="8.4454879814209502E-2"/>
          <c:w val="0.76400808848310298"/>
          <c:h val="0.61339205786514805"/>
        </c:manualLayout>
      </c:layout>
      <c:scatterChart>
        <c:scatterStyle val="lineMarker"/>
        <c:varyColors val="0"/>
        <c:ser>
          <c:idx val="0"/>
          <c:order val="0"/>
          <c:tx>
            <c:strRef>
              <c:f>TP!$B$48</c:f>
              <c:strCache>
                <c:ptCount val="1"/>
                <c:pt idx="0">
                  <c:v>Group A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P!$D$53:$S$53</c:f>
                <c:numCache>
                  <c:formatCode>General</c:formatCode>
                  <c:ptCount val="16"/>
                  <c:pt idx="0">
                    <c:v>2.8738919580485272</c:v>
                  </c:pt>
                  <c:pt idx="1">
                    <c:v>6.2651558780381231</c:v>
                  </c:pt>
                  <c:pt idx="2">
                    <c:v>2.6609875738571609</c:v>
                  </c:pt>
                  <c:pt idx="3">
                    <c:v>2.4230252251491322</c:v>
                  </c:pt>
                  <c:pt idx="4">
                    <c:v>3.0846945712280802</c:v>
                  </c:pt>
                  <c:pt idx="5">
                    <c:v>4.6639124787672266</c:v>
                  </c:pt>
                  <c:pt idx="6">
                    <c:v>3.8388791918841361</c:v>
                  </c:pt>
                  <c:pt idx="7">
                    <c:v>3.0262233558197571</c:v>
                  </c:pt>
                  <c:pt idx="8">
                    <c:v>4.456908707324394</c:v>
                  </c:pt>
                  <c:pt idx="9">
                    <c:v>3.4599612341390471</c:v>
                  </c:pt>
                  <c:pt idx="10">
                    <c:v>2.9232415189356149</c:v>
                  </c:pt>
                  <c:pt idx="11">
                    <c:v>2.7339835127454601</c:v>
                  </c:pt>
                  <c:pt idx="12">
                    <c:v>2.4410240741518732</c:v>
                  </c:pt>
                  <c:pt idx="13">
                    <c:v>1.8797873858497931</c:v>
                  </c:pt>
                  <c:pt idx="14">
                    <c:v>2.974102891908752</c:v>
                  </c:pt>
                  <c:pt idx="15">
                    <c:v>2.146249129508496</c:v>
                  </c:pt>
                </c:numCache>
              </c:numRef>
            </c:plus>
            <c:minus>
              <c:numRef>
                <c:f>TP!$D$53:$S$53</c:f>
                <c:numCache>
                  <c:formatCode>General</c:formatCode>
                  <c:ptCount val="16"/>
                  <c:pt idx="0">
                    <c:v>2.8738919580485272</c:v>
                  </c:pt>
                  <c:pt idx="1">
                    <c:v>6.2651558780381231</c:v>
                  </c:pt>
                  <c:pt idx="2">
                    <c:v>2.6609875738571609</c:v>
                  </c:pt>
                  <c:pt idx="3">
                    <c:v>2.4230252251491322</c:v>
                  </c:pt>
                  <c:pt idx="4">
                    <c:v>3.0846945712280802</c:v>
                  </c:pt>
                  <c:pt idx="5">
                    <c:v>4.6639124787672266</c:v>
                  </c:pt>
                  <c:pt idx="6">
                    <c:v>3.8388791918841361</c:v>
                  </c:pt>
                  <c:pt idx="7">
                    <c:v>3.0262233558197571</c:v>
                  </c:pt>
                  <c:pt idx="8">
                    <c:v>4.456908707324394</c:v>
                  </c:pt>
                  <c:pt idx="9">
                    <c:v>3.4599612341390471</c:v>
                  </c:pt>
                  <c:pt idx="10">
                    <c:v>2.9232415189356149</c:v>
                  </c:pt>
                  <c:pt idx="11">
                    <c:v>2.7339835127454601</c:v>
                  </c:pt>
                  <c:pt idx="12">
                    <c:v>2.4410240741518732</c:v>
                  </c:pt>
                  <c:pt idx="13">
                    <c:v>1.8797873858497931</c:v>
                  </c:pt>
                  <c:pt idx="14">
                    <c:v>2.974102891908752</c:v>
                  </c:pt>
                  <c:pt idx="15">
                    <c:v>2.146249129508496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noFill/>
                <a:round/>
              </a:ln>
              <a:effectLst/>
            </c:spPr>
          </c:errBars>
          <c:xVal>
            <c:numRef>
              <c:f>TP!$D$47:$S$47</c:f>
              <c:numCache>
                <c:formatCode>General</c:formatCode>
                <c:ptCount val="16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  <c:pt idx="7">
                  <c:v>42</c:v>
                </c:pt>
                <c:pt idx="8">
                  <c:v>49</c:v>
                </c:pt>
                <c:pt idx="9">
                  <c:v>56</c:v>
                </c:pt>
                <c:pt idx="10">
                  <c:v>63</c:v>
                </c:pt>
                <c:pt idx="11">
                  <c:v>70</c:v>
                </c:pt>
                <c:pt idx="12">
                  <c:v>76</c:v>
                </c:pt>
                <c:pt idx="13">
                  <c:v>84</c:v>
                </c:pt>
                <c:pt idx="14">
                  <c:v>91</c:v>
                </c:pt>
                <c:pt idx="15">
                  <c:v>98</c:v>
                </c:pt>
              </c:numCache>
            </c:numRef>
          </c:xVal>
          <c:yVal>
            <c:numRef>
              <c:f>TP!$D$48:$S$48</c:f>
              <c:numCache>
                <c:formatCode>General</c:formatCode>
                <c:ptCount val="16"/>
                <c:pt idx="0">
                  <c:v>54.698472000000002</c:v>
                </c:pt>
                <c:pt idx="1">
                  <c:v>62.422517999999997</c:v>
                </c:pt>
                <c:pt idx="2">
                  <c:v>60.40283666666646</c:v>
                </c:pt>
                <c:pt idx="3">
                  <c:v>58.628369000000014</c:v>
                </c:pt>
                <c:pt idx="4">
                  <c:v>62.136854000000007</c:v>
                </c:pt>
                <c:pt idx="5">
                  <c:v>59.245863</c:v>
                </c:pt>
                <c:pt idx="6">
                  <c:v>63.309466999999998</c:v>
                </c:pt>
                <c:pt idx="7">
                  <c:v>65.474468999999999</c:v>
                </c:pt>
                <c:pt idx="8">
                  <c:v>64.582154000000003</c:v>
                </c:pt>
                <c:pt idx="9">
                  <c:v>64.074534999999983</c:v>
                </c:pt>
                <c:pt idx="10">
                  <c:v>66.200119000000001</c:v>
                </c:pt>
                <c:pt idx="11">
                  <c:v>64.631343999999999</c:v>
                </c:pt>
                <c:pt idx="12">
                  <c:v>64.142221000000006</c:v>
                </c:pt>
                <c:pt idx="13">
                  <c:v>61.765990000000002</c:v>
                </c:pt>
                <c:pt idx="14">
                  <c:v>62.89978</c:v>
                </c:pt>
                <c:pt idx="15">
                  <c:v>60.57463200000000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TP!$B$49</c:f>
              <c:strCache>
                <c:ptCount val="1"/>
                <c:pt idx="0">
                  <c:v>Group B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5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P!$D$54:$S$54</c:f>
                <c:numCache>
                  <c:formatCode>General</c:formatCode>
                  <c:ptCount val="16"/>
                  <c:pt idx="0">
                    <c:v>2.3702589843440971</c:v>
                  </c:pt>
                  <c:pt idx="1">
                    <c:v>2.3142535278918781</c:v>
                  </c:pt>
                  <c:pt idx="2">
                    <c:v>2.4629703921939461</c:v>
                  </c:pt>
                  <c:pt idx="3">
                    <c:v>3.031459891573034</c:v>
                  </c:pt>
                  <c:pt idx="4">
                    <c:v>3.6630586762289248</c:v>
                  </c:pt>
                  <c:pt idx="5">
                    <c:v>3.2636095035127539</c:v>
                  </c:pt>
                  <c:pt idx="6">
                    <c:v>2.2060406454913739</c:v>
                  </c:pt>
                  <c:pt idx="7">
                    <c:v>7.1398643407772786</c:v>
                  </c:pt>
                  <c:pt idx="8">
                    <c:v>3.5151703202354212</c:v>
                  </c:pt>
                  <c:pt idx="9">
                    <c:v>4.8019376209042957</c:v>
                  </c:pt>
                  <c:pt idx="10">
                    <c:v>5.6959315117953757</c:v>
                  </c:pt>
                  <c:pt idx="11">
                    <c:v>3.4837015899666239</c:v>
                  </c:pt>
                  <c:pt idx="12">
                    <c:v>3.2179187044858661</c:v>
                  </c:pt>
                  <c:pt idx="13">
                    <c:v>3.2902776438130572</c:v>
                  </c:pt>
                  <c:pt idx="14">
                    <c:v>2.2787502866387102</c:v>
                  </c:pt>
                  <c:pt idx="15">
                    <c:v>2.2779857941839752</c:v>
                  </c:pt>
                </c:numCache>
              </c:numRef>
            </c:plus>
            <c:minus>
              <c:numRef>
                <c:f>TP!$D$54:$S$54</c:f>
                <c:numCache>
                  <c:formatCode>General</c:formatCode>
                  <c:ptCount val="16"/>
                  <c:pt idx="0">
                    <c:v>2.3702589843440971</c:v>
                  </c:pt>
                  <c:pt idx="1">
                    <c:v>2.3142535278918781</c:v>
                  </c:pt>
                  <c:pt idx="2">
                    <c:v>2.4629703921939461</c:v>
                  </c:pt>
                  <c:pt idx="3">
                    <c:v>3.031459891573034</c:v>
                  </c:pt>
                  <c:pt idx="4">
                    <c:v>3.6630586762289248</c:v>
                  </c:pt>
                  <c:pt idx="5">
                    <c:v>3.2636095035127539</c:v>
                  </c:pt>
                  <c:pt idx="6">
                    <c:v>2.2060406454913739</c:v>
                  </c:pt>
                  <c:pt idx="7">
                    <c:v>7.1398643407772786</c:v>
                  </c:pt>
                  <c:pt idx="8">
                    <c:v>3.5151703202354212</c:v>
                  </c:pt>
                  <c:pt idx="9">
                    <c:v>4.8019376209042957</c:v>
                  </c:pt>
                  <c:pt idx="10">
                    <c:v>5.6959315117953757</c:v>
                  </c:pt>
                  <c:pt idx="11">
                    <c:v>3.4837015899666239</c:v>
                  </c:pt>
                  <c:pt idx="12">
                    <c:v>3.2179187044858661</c:v>
                  </c:pt>
                  <c:pt idx="13">
                    <c:v>3.2902776438130572</c:v>
                  </c:pt>
                  <c:pt idx="14">
                    <c:v>2.2787502866387102</c:v>
                  </c:pt>
                  <c:pt idx="15">
                    <c:v>2.2779857941839752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noFill/>
                <a:round/>
              </a:ln>
              <a:effectLst/>
            </c:spPr>
          </c:errBars>
          <c:xVal>
            <c:numRef>
              <c:f>TP!$D$47:$S$47</c:f>
              <c:numCache>
                <c:formatCode>General</c:formatCode>
                <c:ptCount val="16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  <c:pt idx="7">
                  <c:v>42</c:v>
                </c:pt>
                <c:pt idx="8">
                  <c:v>49</c:v>
                </c:pt>
                <c:pt idx="9">
                  <c:v>56</c:v>
                </c:pt>
                <c:pt idx="10">
                  <c:v>63</c:v>
                </c:pt>
                <c:pt idx="11">
                  <c:v>70</c:v>
                </c:pt>
                <c:pt idx="12">
                  <c:v>76</c:v>
                </c:pt>
                <c:pt idx="13">
                  <c:v>84</c:v>
                </c:pt>
                <c:pt idx="14">
                  <c:v>91</c:v>
                </c:pt>
                <c:pt idx="15">
                  <c:v>98</c:v>
                </c:pt>
              </c:numCache>
            </c:numRef>
          </c:xVal>
          <c:yVal>
            <c:numRef>
              <c:f>TP!$D$49:$S$49</c:f>
              <c:numCache>
                <c:formatCode>General</c:formatCode>
                <c:ptCount val="16"/>
                <c:pt idx="0">
                  <c:v>54.178436000000012</c:v>
                </c:pt>
                <c:pt idx="1">
                  <c:v>59.937640000000002</c:v>
                </c:pt>
                <c:pt idx="2">
                  <c:v>57.913026000000002</c:v>
                </c:pt>
                <c:pt idx="3">
                  <c:v>55.630947999999997</c:v>
                </c:pt>
                <c:pt idx="4">
                  <c:v>57.788282000000002</c:v>
                </c:pt>
                <c:pt idx="5">
                  <c:v>54.430462499999997</c:v>
                </c:pt>
                <c:pt idx="6">
                  <c:v>58.154719999999998</c:v>
                </c:pt>
                <c:pt idx="7">
                  <c:v>62.258874000000013</c:v>
                </c:pt>
                <c:pt idx="8">
                  <c:v>59.373354000000013</c:v>
                </c:pt>
                <c:pt idx="9">
                  <c:v>60.301707999999998</c:v>
                </c:pt>
                <c:pt idx="10">
                  <c:v>61.826986000000012</c:v>
                </c:pt>
                <c:pt idx="11">
                  <c:v>62.324112</c:v>
                </c:pt>
                <c:pt idx="12">
                  <c:v>61.002560000000003</c:v>
                </c:pt>
                <c:pt idx="13">
                  <c:v>58.009307999999997</c:v>
                </c:pt>
                <c:pt idx="14">
                  <c:v>59.793481999999997</c:v>
                </c:pt>
                <c:pt idx="15">
                  <c:v>58.81218599999999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480376"/>
        <c:axId val="178479200"/>
      </c:scatterChart>
      <c:valAx>
        <c:axId val="178480376"/>
        <c:scaling>
          <c:orientation val="minMax"/>
          <c:max val="10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rgbClr val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 dirty="0">
                    <a:solidFill>
                      <a:srgbClr val="000000"/>
                    </a:solidFill>
                  </a:rPr>
                  <a:t>Days</a:t>
                </a:r>
                <a:r>
                  <a:rPr lang="en-GB" b="1" baseline="0" dirty="0">
                    <a:solidFill>
                      <a:srgbClr val="000000"/>
                    </a:solidFill>
                  </a:rPr>
                  <a:t> </a:t>
                </a:r>
                <a:r>
                  <a:rPr lang="en-GB" b="1" baseline="0" dirty="0" smtClean="0">
                    <a:solidFill>
                      <a:srgbClr val="000000"/>
                    </a:solidFill>
                  </a:rPr>
                  <a:t>post </a:t>
                </a:r>
                <a:r>
                  <a:rPr lang="en-GB" b="1" baseline="0" dirty="0">
                    <a:solidFill>
                      <a:srgbClr val="000000"/>
                    </a:solidFill>
                  </a:rPr>
                  <a:t>i</a:t>
                </a:r>
                <a:r>
                  <a:rPr lang="en-GB" b="1" baseline="0" dirty="0" smtClean="0">
                    <a:solidFill>
                      <a:srgbClr val="000000"/>
                    </a:solidFill>
                  </a:rPr>
                  <a:t>noculation</a:t>
                </a:r>
                <a:endParaRPr lang="en-GB" b="1" dirty="0">
                  <a:solidFill>
                    <a:srgbClr val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8479200"/>
        <c:crosses val="autoZero"/>
        <c:crossBetween val="midCat"/>
        <c:majorUnit val="10"/>
      </c:valAx>
      <c:valAx>
        <c:axId val="178479200"/>
        <c:scaling>
          <c:orientation val="minMax"/>
          <c:max val="70"/>
          <c:min val="5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rgbClr val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 baseline="0" dirty="0" smtClean="0">
                    <a:solidFill>
                      <a:srgbClr val="000000"/>
                    </a:solidFill>
                  </a:rPr>
                  <a:t>Total </a:t>
                </a:r>
                <a:r>
                  <a:rPr lang="en-GB" b="1" baseline="0" dirty="0">
                    <a:solidFill>
                      <a:srgbClr val="000000"/>
                    </a:solidFill>
                  </a:rPr>
                  <a:t>p</a:t>
                </a:r>
                <a:r>
                  <a:rPr lang="en-GB" b="1" baseline="0" dirty="0" smtClean="0">
                    <a:solidFill>
                      <a:srgbClr val="000000"/>
                    </a:solidFill>
                  </a:rPr>
                  <a:t>rotein </a:t>
                </a:r>
                <a:r>
                  <a:rPr lang="en-GB" b="1" baseline="0" dirty="0">
                    <a:solidFill>
                      <a:srgbClr val="000000"/>
                    </a:solidFill>
                  </a:rPr>
                  <a:t>(g</a:t>
                </a:r>
                <a:r>
                  <a:rPr lang="en-GB" b="1" baseline="0" dirty="0" smtClean="0">
                    <a:solidFill>
                      <a:srgbClr val="000000"/>
                    </a:solidFill>
                  </a:rPr>
                  <a:t>/L)</a:t>
                </a:r>
                <a:endParaRPr lang="en-GB" b="1" dirty="0">
                  <a:solidFill>
                    <a:srgbClr val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3346303501945501E-2"/>
              <c:y val="0.16967450854012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8480376"/>
        <c:crosses val="autoZero"/>
        <c:crossBetween val="midCat"/>
      </c:valAx>
      <c:spPr>
        <a:solidFill>
          <a:srgbClr val="FFFFFF"/>
        </a:solidFill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6B1714-D261-8841-BE09-742EBA9F556E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40FC0F-047A-B840-A582-53363740ED77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280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0FC0F-047A-B840-A582-53363740ED7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6169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CH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2619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8166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6073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2079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CH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8134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8172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3519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8209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7654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8609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276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CH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CH" smtClean="0"/>
              <a:t>Mastertextformat bearbeiten</a:t>
            </a:r>
          </a:p>
          <a:p>
            <a:pPr lvl="1"/>
            <a:r>
              <a:rPr lang="de-CH" smtClean="0"/>
              <a:t>Zweite Ebene</a:t>
            </a:r>
          </a:p>
          <a:p>
            <a:pPr lvl="2"/>
            <a:r>
              <a:rPr lang="de-CH" smtClean="0"/>
              <a:t>Dritte Ebene</a:t>
            </a:r>
          </a:p>
          <a:p>
            <a:pPr lvl="3"/>
            <a:r>
              <a:rPr lang="de-CH" smtClean="0"/>
              <a:t>Vierte Ebene</a:t>
            </a:r>
          </a:p>
          <a:p>
            <a:pPr lvl="4"/>
            <a:r>
              <a:rPr lang="de-CH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D58A3-FF84-DD47-AF93-5716E39EFC93}" type="datetimeFigureOut">
              <a:rPr lang="de-DE" smtClean="0"/>
              <a:t>21.07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3AAB46-09F2-E548-B30D-0521CF2F4AF1}" type="slidenum">
              <a:rPr lang="de-DE" smtClean="0"/>
              <a:t>‹N°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7104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6996977"/>
              </p:ext>
            </p:extLst>
          </p:nvPr>
        </p:nvGraphicFramePr>
        <p:xfrm>
          <a:off x="184150" y="770459"/>
          <a:ext cx="4159250" cy="22321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5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6185501"/>
              </p:ext>
            </p:extLst>
          </p:nvPr>
        </p:nvGraphicFramePr>
        <p:xfrm>
          <a:off x="194180" y="5028711"/>
          <a:ext cx="3259715" cy="19842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9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2554172"/>
              </p:ext>
            </p:extLst>
          </p:nvPr>
        </p:nvGraphicFramePr>
        <p:xfrm>
          <a:off x="247650" y="3126846"/>
          <a:ext cx="3263900" cy="19548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184151" y="1092224"/>
            <a:ext cx="423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156670" y="2799311"/>
            <a:ext cx="454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84151" y="4744525"/>
            <a:ext cx="492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28" name="Rechteck 27"/>
          <p:cNvSpPr/>
          <p:nvPr/>
        </p:nvSpPr>
        <p:spPr>
          <a:xfrm>
            <a:off x="1200142" y="1353082"/>
            <a:ext cx="1115202" cy="69158"/>
          </a:xfrm>
          <a:prstGeom prst="rect">
            <a:avLst/>
          </a:prstGeom>
          <a:pattFill prst="pct20">
            <a:fgClr>
              <a:schemeClr val="tx1"/>
            </a:fgClr>
            <a:bgClr>
              <a:prstClr val="white"/>
            </a:bgClr>
          </a:patt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Rechteck 28"/>
          <p:cNvSpPr/>
          <p:nvPr/>
        </p:nvSpPr>
        <p:spPr>
          <a:xfrm flipV="1">
            <a:off x="1200143" y="1274226"/>
            <a:ext cx="762007" cy="5502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1202276" y="3126846"/>
            <a:ext cx="1113069" cy="69158"/>
          </a:xfrm>
          <a:prstGeom prst="rect">
            <a:avLst/>
          </a:prstGeom>
          <a:pattFill prst="pct20">
            <a:fgClr>
              <a:schemeClr val="tx1"/>
            </a:fgClr>
            <a:bgClr>
              <a:prstClr val="white"/>
            </a:bgClr>
          </a:patt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Rechteck 30"/>
          <p:cNvSpPr/>
          <p:nvPr/>
        </p:nvSpPr>
        <p:spPr>
          <a:xfrm flipV="1">
            <a:off x="1202270" y="3054340"/>
            <a:ext cx="766230" cy="5502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1199602" y="5178980"/>
            <a:ext cx="1105449" cy="69158"/>
          </a:xfrm>
          <a:prstGeom prst="rect">
            <a:avLst/>
          </a:prstGeom>
          <a:pattFill prst="pct20">
            <a:fgClr>
              <a:schemeClr val="tx1"/>
            </a:fgClr>
            <a:bgClr>
              <a:prstClr val="white"/>
            </a:bgClr>
          </a:patt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Rechteck 32"/>
          <p:cNvSpPr/>
          <p:nvPr/>
        </p:nvSpPr>
        <p:spPr>
          <a:xfrm flipV="1">
            <a:off x="1199596" y="5100124"/>
            <a:ext cx="762553" cy="5502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Gleichschenkliges Dreieck 40"/>
          <p:cNvSpPr/>
          <p:nvPr/>
        </p:nvSpPr>
        <p:spPr>
          <a:xfrm flipV="1">
            <a:off x="880532" y="1305976"/>
            <a:ext cx="93135" cy="104257"/>
          </a:xfrm>
          <a:prstGeom prst="triangle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Gleichschenkliges Dreieck 45"/>
          <p:cNvSpPr/>
          <p:nvPr/>
        </p:nvSpPr>
        <p:spPr>
          <a:xfrm flipV="1">
            <a:off x="880533" y="3150292"/>
            <a:ext cx="93135" cy="104257"/>
          </a:xfrm>
          <a:prstGeom prst="triangle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Gleichschenkliges Dreieck 50"/>
          <p:cNvSpPr/>
          <p:nvPr/>
        </p:nvSpPr>
        <p:spPr>
          <a:xfrm flipV="1">
            <a:off x="886355" y="5155145"/>
            <a:ext cx="93135" cy="104257"/>
          </a:xfrm>
          <a:prstGeom prst="triangle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2" name="Textfeld 41"/>
          <p:cNvSpPr txBox="1"/>
          <p:nvPr/>
        </p:nvSpPr>
        <p:spPr>
          <a:xfrm>
            <a:off x="611188" y="2254225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43" name="Textfeld 42"/>
          <p:cNvSpPr txBox="1"/>
          <p:nvPr/>
        </p:nvSpPr>
        <p:spPr>
          <a:xfrm>
            <a:off x="947737" y="2146276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47" name="Textfeld 46"/>
          <p:cNvSpPr txBox="1"/>
          <p:nvPr/>
        </p:nvSpPr>
        <p:spPr>
          <a:xfrm>
            <a:off x="2876020" y="2036209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52" name="Textfeld 51"/>
          <p:cNvSpPr txBox="1"/>
          <p:nvPr/>
        </p:nvSpPr>
        <p:spPr>
          <a:xfrm>
            <a:off x="1491701" y="3188813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53" name="Textfeld 52"/>
          <p:cNvSpPr txBox="1"/>
          <p:nvPr/>
        </p:nvSpPr>
        <p:spPr>
          <a:xfrm>
            <a:off x="1142994" y="3318933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54" name="Textfeld 53"/>
          <p:cNvSpPr txBox="1"/>
          <p:nvPr/>
        </p:nvSpPr>
        <p:spPr>
          <a:xfrm>
            <a:off x="1838834" y="3121136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56" name="Textfeld 55"/>
          <p:cNvSpPr txBox="1"/>
          <p:nvPr/>
        </p:nvSpPr>
        <p:spPr>
          <a:xfrm>
            <a:off x="1125537" y="5344583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  <p:sp>
        <p:nvSpPr>
          <p:cNvPr id="57" name="Textfeld 56"/>
          <p:cNvSpPr txBox="1"/>
          <p:nvPr/>
        </p:nvSpPr>
        <p:spPr>
          <a:xfrm>
            <a:off x="1474761" y="5207931"/>
            <a:ext cx="31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*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1913128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Format A4 (210 x 297 mm)</PresentationFormat>
  <Paragraphs>18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Design</vt:lpstr>
      <vt:lpstr>Présentation PowerPoint</vt:lpstr>
    </vt:vector>
  </TitlesOfParts>
  <Company>Univeristät Züri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arbara Willi</dc:creator>
  <cp:lastModifiedBy>ecoulamy</cp:lastModifiedBy>
  <cp:revision>104</cp:revision>
  <cp:lastPrinted>2015-04-20T12:52:59Z</cp:lastPrinted>
  <dcterms:created xsi:type="dcterms:W3CDTF">2015-04-03T13:59:40Z</dcterms:created>
  <dcterms:modified xsi:type="dcterms:W3CDTF">2016-07-21T08:19:18Z</dcterms:modified>
</cp:coreProperties>
</file>